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B882"/>
    <a:srgbClr val="354F5F"/>
    <a:srgbClr val="485063"/>
    <a:srgbClr val="343D52"/>
    <a:srgbClr val="152538"/>
    <a:srgbClr val="0C2D4C"/>
    <a:srgbClr val="2D3E55"/>
    <a:srgbClr val="011893"/>
    <a:srgbClr val="0054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694"/>
  </p:normalViewPr>
  <p:slideViewPr>
    <p:cSldViewPr snapToGrid="0" snapToObjects="1">
      <p:cViewPr>
        <p:scale>
          <a:sx n="95" d="100"/>
          <a:sy n="95" d="100"/>
        </p:scale>
        <p:origin x="-228" y="-1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</a:t>
            </a:r>
            <a:r>
              <a:rPr lang="en-US" sz="1200" dirty="0" err="1">
                <a:solidFill>
                  <a:schemeClr val="bg1"/>
                </a:solidFill>
              </a:rPr>
              <a:t>TheTxIDJournal</a:t>
            </a:r>
            <a:r>
              <a:rPr lang="en-US" sz="1200" dirty="0">
                <a:solidFill>
                  <a:schemeClr val="bg1"/>
                </a:solidFill>
              </a:rPr>
              <a:t>  @Author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630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solidFill>
                  <a:schemeClr val="bg1"/>
                </a:solidFill>
              </a:rPr>
              <a:t>R.Minucci</a:t>
            </a:r>
            <a:r>
              <a:rPr lang="en-US" sz="1200" dirty="0">
                <a:solidFill>
                  <a:schemeClr val="bg1"/>
                </a:solidFill>
              </a:rPr>
              <a:t>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5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3"/>
            <a:ext cx="119234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challenge of bacterial infections during intensive care unit stay after heart transplantation</a:t>
            </a:r>
            <a:endParaRPr lang="en-US" sz="2000" b="1" dirty="0">
              <a:solidFill>
                <a:schemeClr val="bg1"/>
              </a:solidFill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C365A6BD-4835-D994-0DC0-B084F188C586}"/>
              </a:ext>
            </a:extLst>
          </p:cNvPr>
          <p:cNvSpPr txBox="1"/>
          <p:nvPr/>
        </p:nvSpPr>
        <p:spPr>
          <a:xfrm>
            <a:off x="501459" y="1065751"/>
            <a:ext cx="5442141" cy="3829190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</a:rPr>
              <a:t>Study design and population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bservational prospective study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art 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nsplanted adult patients 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P/VAPs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SIs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agnosed during ICU stay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ioperative Antimicrobial prophylaxis (PAP): 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comycin from 1</a:t>
            </a:r>
            <a:r>
              <a:rPr lang="en-GB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n2015 to 30</a:t>
            </a:r>
            <a:r>
              <a:rPr lang="en-GB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p2018 (period 1); vancomycin plus piperacillin/tazobactam from 1</a:t>
            </a:r>
            <a:r>
              <a:rPr lang="en-GB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ct 2018 to 31</a:t>
            </a:r>
            <a:r>
              <a:rPr lang="en-GB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ug 2023 (period 2) 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ariables included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ge, gender,  ECMO, L-VAD, BMI, WBC, lymphocyte, creatinine, primary graft dysfunction, re-do procedure, MDR rectal colonisation, CMV-DNA, perioperative antimicrobial </a:t>
            </a:r>
            <a:r>
              <a:rPr lang="en-GB" sz="140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ophylaxis </a:t>
            </a:r>
          </a:p>
          <a:p>
            <a:pPr marL="285750" indent="-285750" algn="just">
              <a:lnSpc>
                <a:spcPct val="150000"/>
              </a:lnSpc>
              <a:buFont typeface="Wingdings" panose="05000000000000000000" pitchFamily="2" charset="2"/>
              <a:buChar char="Ø"/>
            </a:pPr>
            <a:endParaRPr lang="it-IT" sz="140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1FB4DEC2-E484-0D31-1402-F9742457F689}"/>
              </a:ext>
            </a:extLst>
          </p:cNvPr>
          <p:cNvSpPr txBox="1"/>
          <p:nvPr/>
        </p:nvSpPr>
        <p:spPr>
          <a:xfrm>
            <a:off x="6018028" y="1094527"/>
            <a:ext cx="5765804" cy="3829190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it-IT" sz="1400" b="1" dirty="0"/>
              <a:t>Key </a:t>
            </a:r>
            <a:r>
              <a:rPr lang="it-IT" sz="1400" b="1" dirty="0" err="1"/>
              <a:t>findings</a:t>
            </a:r>
            <a:endParaRPr lang="it-IT" sz="1400" b="1" dirty="0"/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106 patients included, 35.8% with infections. Incidence  was 2.2 per 100  ICU </a:t>
            </a:r>
            <a:r>
              <a:rPr lang="en-GB" sz="1400" dirty="0" err="1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saty</a:t>
            </a:r>
            <a:r>
              <a:rPr lang="en-GB" sz="14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days (95% CI 1.7-2.8). Median length of ICU stay was 8 days (IQR: 6-11) and  27 days (IQR 14-52) for those without/with infectious events (p&lt;0.001).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b="1" dirty="0">
                <a:ea typeface="Calibri" panose="020F0502020204030204" pitchFamily="34" charset="0"/>
                <a:cs typeface="Calibri" panose="020F0502020204030204" pitchFamily="34" charset="0"/>
              </a:rPr>
              <a:t>Gram-negative bacteria </a:t>
            </a:r>
            <a:r>
              <a:rPr lang="en-GB" sz="1400" dirty="0">
                <a:ea typeface="Calibri" panose="020F0502020204030204" pitchFamily="34" charset="0"/>
                <a:cs typeface="Calibri" panose="020F0502020204030204" pitchFamily="34" charset="0"/>
              </a:rPr>
              <a:t>were associated with 62.8% of BSIs (mainly represented by </a:t>
            </a:r>
            <a:r>
              <a:rPr lang="en-GB" sz="1400" i="1" dirty="0" err="1">
                <a:ea typeface="Calibri" panose="020F0502020204030204" pitchFamily="34" charset="0"/>
                <a:cs typeface="Calibri" panose="020F0502020204030204" pitchFamily="34" charset="0"/>
              </a:rPr>
              <a:t>Enterobacterales</a:t>
            </a:r>
            <a:r>
              <a:rPr lang="en-GB" sz="1400" dirty="0">
                <a:ea typeface="Calibri" panose="020F0502020204030204" pitchFamily="34" charset="0"/>
                <a:cs typeface="Calibri" panose="020F0502020204030204" pitchFamily="34" charset="0"/>
              </a:rPr>
              <a:t>) and </a:t>
            </a:r>
            <a:r>
              <a:rPr lang="en-GB" sz="1400" dirty="0">
                <a:ea typeface="Calibri" panose="020F0502020204030204" pitchFamily="34" charset="0"/>
              </a:rPr>
              <a:t>77.9% of HAP/VAD</a:t>
            </a:r>
            <a:endParaRPr lang="it-IT" sz="1400" b="1" dirty="0"/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dirty="0">
                <a:effectLst/>
                <a:ea typeface="Calibri" panose="020F0502020204030204" pitchFamily="34" charset="0"/>
              </a:rPr>
              <a:t>Colonisation with MDR bacteria (HR 2.21, 95%CI 1.12-4-35) was associated with increased risk of infections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400" dirty="0">
                <a:effectLst/>
                <a:ea typeface="Calibri" panose="020F0502020204030204" pitchFamily="34" charset="0"/>
              </a:rPr>
              <a:t>PAP covering Gram negative bacteria at transplant (HR 0.45, 95%CI 0.23-0.90, p=0.023) was a protective factors</a:t>
            </a:r>
          </a:p>
          <a:p>
            <a:pPr>
              <a:lnSpc>
                <a:spcPct val="150000"/>
              </a:lnSpc>
            </a:pPr>
            <a:endParaRPr lang="it-IT" sz="1400" b="1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B030EA4-80B4-E482-ED2F-9561FB57E6F0}"/>
              </a:ext>
            </a:extLst>
          </p:cNvPr>
          <p:cNvSpPr txBox="1"/>
          <p:nvPr/>
        </p:nvSpPr>
        <p:spPr>
          <a:xfrm>
            <a:off x="445272" y="5046250"/>
            <a:ext cx="11338559" cy="1028423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nclusion</a:t>
            </a:r>
          </a:p>
          <a:p>
            <a:pPr algn="just">
              <a:lnSpc>
                <a:spcPct val="150000"/>
              </a:lnSpc>
            </a:pP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m negative infections represent the major challenge for heart transplanted patients during ICU stay, infections after HT are associated with longer ICU stay, PAP covering a wider range of Gram negative bacteria was a protective factor for acquiring infections post HT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284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Elena Seminari</cp:lastModifiedBy>
  <cp:revision>14</cp:revision>
  <dcterms:created xsi:type="dcterms:W3CDTF">2021-10-22T20:34:26Z</dcterms:created>
  <dcterms:modified xsi:type="dcterms:W3CDTF">2025-01-28T20:30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